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1092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CE982-3DA5-458F-AA97-59D3CA9AD550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F9E5-BC07-429D-86ED-F8E1D97D6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44292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CE982-3DA5-458F-AA97-59D3CA9AD550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F9E5-BC07-429D-86ED-F8E1D97D6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6797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CE982-3DA5-458F-AA97-59D3CA9AD550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F9E5-BC07-429D-86ED-F8E1D97D6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64166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CE982-3DA5-458F-AA97-59D3CA9AD550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F9E5-BC07-429D-86ED-F8E1D97D6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0873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CE982-3DA5-458F-AA97-59D3CA9AD550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F9E5-BC07-429D-86ED-F8E1D97D6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26530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CE982-3DA5-458F-AA97-59D3CA9AD550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F9E5-BC07-429D-86ED-F8E1D97D6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9403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CE982-3DA5-458F-AA97-59D3CA9AD550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F9E5-BC07-429D-86ED-F8E1D97D6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84539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CE982-3DA5-458F-AA97-59D3CA9AD550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F9E5-BC07-429D-86ED-F8E1D97D6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1390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CE982-3DA5-458F-AA97-59D3CA9AD550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F9E5-BC07-429D-86ED-F8E1D97D6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7663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CE982-3DA5-458F-AA97-59D3CA9AD550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F9E5-BC07-429D-86ED-F8E1D97D6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4335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CE982-3DA5-458F-AA97-59D3CA9AD550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1F9E5-BC07-429D-86ED-F8E1D97D6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34300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FCE982-3DA5-458F-AA97-59D3CA9AD550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41F9E5-BC07-429D-86ED-F8E1D97D6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31787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25974" y="3247129"/>
            <a:ext cx="582736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munohistochemistry for ceruloplasmin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the WKY nephritic kidneys (10 days following NTN).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p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sitiv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crophage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 seen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glomerulus (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th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nal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stitium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735" y="1339690"/>
            <a:ext cx="2330889" cy="169247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3416" y="1339690"/>
            <a:ext cx="2330889" cy="1692471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692696" y="1001136"/>
            <a:ext cx="3049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 smtClean="0"/>
              <a:t>A</a:t>
            </a:r>
            <a:endParaRPr lang="en-GB" sz="16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3628116" y="1001136"/>
            <a:ext cx="3049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B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6133554" y="5299"/>
            <a:ext cx="7665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54736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39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mperial Colle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hmoaras, Jacques V</dc:creator>
  <cp:lastModifiedBy>Behmoaras, Jacques V</cp:lastModifiedBy>
  <cp:revision>7</cp:revision>
  <dcterms:created xsi:type="dcterms:W3CDTF">2017-03-14T13:29:01Z</dcterms:created>
  <dcterms:modified xsi:type="dcterms:W3CDTF">2017-04-19T15:09:46Z</dcterms:modified>
</cp:coreProperties>
</file>